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6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0000FF"/>
    <a:srgbClr val="FF33CC"/>
    <a:srgbClr val="FFC000"/>
    <a:srgbClr val="FFCC99"/>
    <a:srgbClr val="00CCFF"/>
    <a:srgbClr val="6699FF"/>
    <a:srgbClr val="6666FF"/>
    <a:srgbClr val="99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462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Book2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atient 1'!$L$7</c:f>
              <c:strCache>
                <c:ptCount val="1"/>
                <c:pt idx="0">
                  <c:v>M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ient 1'!$M$13:$P$13</c:f>
                <c:numCache>
                  <c:formatCode>General</c:formatCode>
                  <c:ptCount val="4"/>
                  <c:pt idx="0">
                    <c:v>1.041025135783634</c:v>
                  </c:pt>
                  <c:pt idx="1">
                    <c:v>2.3586719427112648</c:v>
                  </c:pt>
                  <c:pt idx="2">
                    <c:v>1.7009801096230799</c:v>
                  </c:pt>
                  <c:pt idx="3">
                    <c:v>2.740437921208926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Untreated</c:v>
              </c:pt>
              <c:pt idx="1">
                <c:v> Tubastatin A</c:v>
              </c:pt>
              <c:pt idx="2">
                <c:v> ACY-1215</c:v>
              </c:pt>
              <c:pt idx="3">
                <c:v> ACY-738</c:v>
              </c:pt>
            </c:strLit>
          </c:cat>
          <c:val>
            <c:numRef>
              <c:f>'patient 1'!$M$7:$P$7</c:f>
              <c:numCache>
                <c:formatCode>General</c:formatCode>
                <c:ptCount val="4"/>
                <c:pt idx="0">
                  <c:v>9.1333333333333329</c:v>
                </c:pt>
                <c:pt idx="1">
                  <c:v>13.533333333333333</c:v>
                </c:pt>
                <c:pt idx="2">
                  <c:v>11.933333333333332</c:v>
                </c:pt>
                <c:pt idx="3">
                  <c:v>12.8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389-441D-87DB-E7C1D06B70F0}"/>
            </c:ext>
          </c:extLst>
        </c:ser>
        <c:ser>
          <c:idx val="1"/>
          <c:order val="1"/>
          <c:tx>
            <c:strRef>
              <c:f>'patient 1'!$L$8</c:f>
              <c:strCache>
                <c:ptCount val="1"/>
                <c:pt idx="0">
                  <c:v>MM+T Cell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ient 1'!$M$14:$P$14</c:f>
                <c:numCache>
                  <c:formatCode>General</c:formatCode>
                  <c:ptCount val="4"/>
                  <c:pt idx="0">
                    <c:v>17.832647961907764</c:v>
                  </c:pt>
                  <c:pt idx="1">
                    <c:v>8.1223970189429249</c:v>
                  </c:pt>
                  <c:pt idx="2">
                    <c:v>11.447270417003356</c:v>
                  </c:pt>
                  <c:pt idx="3">
                    <c:v>3.1085902485424644</c:v>
                  </c:pt>
                </c:numCache>
              </c:numRef>
            </c:plus>
            <c:minus>
              <c:numRef>
                <c:f>'patient 1'!$M$14:$P$14</c:f>
                <c:numCache>
                  <c:formatCode>General</c:formatCode>
                  <c:ptCount val="4"/>
                  <c:pt idx="0">
                    <c:v>17.832647961907764</c:v>
                  </c:pt>
                  <c:pt idx="1">
                    <c:v>8.1223970189429249</c:v>
                  </c:pt>
                  <c:pt idx="2">
                    <c:v>11.447270417003356</c:v>
                  </c:pt>
                  <c:pt idx="3">
                    <c:v>3.10859024854246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Untreated</c:v>
              </c:pt>
              <c:pt idx="1">
                <c:v> Tubastatin A</c:v>
              </c:pt>
              <c:pt idx="2">
                <c:v> ACY-1215</c:v>
              </c:pt>
              <c:pt idx="3">
                <c:v> ACY-738</c:v>
              </c:pt>
            </c:strLit>
          </c:cat>
          <c:val>
            <c:numRef>
              <c:f>'patient 1'!$M$8:$P$8</c:f>
              <c:numCache>
                <c:formatCode>General</c:formatCode>
                <c:ptCount val="4"/>
                <c:pt idx="0">
                  <c:v>52.966666666666669</c:v>
                </c:pt>
                <c:pt idx="1">
                  <c:v>50.966666666666669</c:v>
                </c:pt>
                <c:pt idx="2">
                  <c:v>22.599999999999998</c:v>
                </c:pt>
                <c:pt idx="3">
                  <c:v>77.8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389-441D-87DB-E7C1D06B70F0}"/>
            </c:ext>
          </c:extLst>
        </c:ser>
        <c:ser>
          <c:idx val="2"/>
          <c:order val="2"/>
          <c:tx>
            <c:strRef>
              <c:f>'patient 1'!$L$9</c:f>
              <c:strCache>
                <c:ptCount val="1"/>
                <c:pt idx="0">
                  <c:v>MM+HLA Ab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ient 1'!$M$15:$P$15</c:f>
                <c:numCache>
                  <c:formatCode>General</c:formatCode>
                  <c:ptCount val="4"/>
                  <c:pt idx="0">
                    <c:v>1.0987720418721807</c:v>
                  </c:pt>
                  <c:pt idx="1">
                    <c:v>1.4089712559168757</c:v>
                  </c:pt>
                  <c:pt idx="2">
                    <c:v>1.0851881557284648</c:v>
                  </c:pt>
                  <c:pt idx="3">
                    <c:v>0.69572504147352165</c:v>
                  </c:pt>
                </c:numCache>
              </c:numRef>
            </c:plus>
            <c:minus>
              <c:numRef>
                <c:f>'patient 1'!$M$15:$P$15</c:f>
                <c:numCache>
                  <c:formatCode>General</c:formatCode>
                  <c:ptCount val="4"/>
                  <c:pt idx="0">
                    <c:v>1.0987720418721807</c:v>
                  </c:pt>
                  <c:pt idx="1">
                    <c:v>1.4089712559168757</c:v>
                  </c:pt>
                  <c:pt idx="2">
                    <c:v>1.0851881557284648</c:v>
                  </c:pt>
                  <c:pt idx="3">
                    <c:v>0.6957250414735216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Untreated</c:v>
              </c:pt>
              <c:pt idx="1">
                <c:v> Tubastatin A</c:v>
              </c:pt>
              <c:pt idx="2">
                <c:v> ACY-1215</c:v>
              </c:pt>
              <c:pt idx="3">
                <c:v> ACY-738</c:v>
              </c:pt>
            </c:strLit>
          </c:cat>
          <c:val>
            <c:numRef>
              <c:f>'patient 1'!$M$9:$P$9</c:f>
              <c:numCache>
                <c:formatCode>General</c:formatCode>
                <c:ptCount val="4"/>
                <c:pt idx="0">
                  <c:v>8.0200000000000014</c:v>
                </c:pt>
                <c:pt idx="1">
                  <c:v>11.933333333333332</c:v>
                </c:pt>
                <c:pt idx="2">
                  <c:v>7.4366666666666665</c:v>
                </c:pt>
                <c:pt idx="3">
                  <c:v>8.013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389-441D-87DB-E7C1D06B70F0}"/>
            </c:ext>
          </c:extLst>
        </c:ser>
        <c:ser>
          <c:idx val="3"/>
          <c:order val="3"/>
          <c:tx>
            <c:strRef>
              <c:f>'patient 1'!$L$10</c:f>
              <c:strCache>
                <c:ptCount val="1"/>
                <c:pt idx="0">
                  <c:v>MM+T Cells+HLA Ab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ient 1'!$M$16:$P$16</c:f>
                <c:numCache>
                  <c:formatCode>General</c:formatCode>
                  <c:ptCount val="4"/>
                  <c:pt idx="0">
                    <c:v>2.8860526675720921</c:v>
                  </c:pt>
                  <c:pt idx="1">
                    <c:v>3.7402807381264807</c:v>
                  </c:pt>
                  <c:pt idx="2">
                    <c:v>6.5151694784812229</c:v>
                  </c:pt>
                  <c:pt idx="3">
                    <c:v>1.3892443989449808</c:v>
                  </c:pt>
                </c:numCache>
              </c:numRef>
            </c:plus>
            <c:minus>
              <c:numRef>
                <c:f>'patient 1'!$M$16:$P$16</c:f>
                <c:numCache>
                  <c:formatCode>General</c:formatCode>
                  <c:ptCount val="4"/>
                  <c:pt idx="0">
                    <c:v>2.8860526675720921</c:v>
                  </c:pt>
                  <c:pt idx="1">
                    <c:v>3.7402807381264807</c:v>
                  </c:pt>
                  <c:pt idx="2">
                    <c:v>6.5151694784812229</c:v>
                  </c:pt>
                  <c:pt idx="3">
                    <c:v>1.38924439894498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Untreated</c:v>
              </c:pt>
              <c:pt idx="1">
                <c:v> Tubastatin A</c:v>
              </c:pt>
              <c:pt idx="2">
                <c:v> ACY-1215</c:v>
              </c:pt>
              <c:pt idx="3">
                <c:v> ACY-738</c:v>
              </c:pt>
            </c:strLit>
          </c:cat>
          <c:val>
            <c:numRef>
              <c:f>'patient 1'!$M$10:$P$10</c:f>
              <c:numCache>
                <c:formatCode>General</c:formatCode>
                <c:ptCount val="4"/>
                <c:pt idx="0">
                  <c:v>12.89</c:v>
                </c:pt>
                <c:pt idx="1">
                  <c:v>10.393333333333333</c:v>
                </c:pt>
                <c:pt idx="2">
                  <c:v>10.393333333333333</c:v>
                </c:pt>
                <c:pt idx="3">
                  <c:v>15.8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389-441D-87DB-E7C1D06B70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4406447"/>
        <c:axId val="564289087"/>
      </c:barChart>
      <c:catAx>
        <c:axId val="57440644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289087"/>
        <c:crosses val="autoZero"/>
        <c:auto val="1"/>
        <c:lblAlgn val="ctr"/>
        <c:lblOffset val="100"/>
        <c:noMultiLvlLbl val="0"/>
      </c:catAx>
      <c:valAx>
        <c:axId val="56428908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ercent Late Apoptotic</a:t>
                </a:r>
              </a:p>
            </c:rich>
          </c:tx>
          <c:layout>
            <c:manualLayout>
              <c:xMode val="edge"/>
              <c:yMode val="edge"/>
              <c:x val="1.0408768470141572E-2"/>
              <c:y val="0.1806948218573558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74406447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atient 1'!$L$7</c:f>
              <c:strCache>
                <c:ptCount val="1"/>
                <c:pt idx="0">
                  <c:v>M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ient 1'!$R$13:$U$13</c:f>
                <c:numCache>
                  <c:formatCode>General</c:formatCode>
                  <c:ptCount val="4"/>
                  <c:pt idx="0">
                    <c:v>4.0211565500487518</c:v>
                  </c:pt>
                  <c:pt idx="1">
                    <c:v>4.4266127004742568</c:v>
                  </c:pt>
                  <c:pt idx="2">
                    <c:v>1.4000000000000028</c:v>
                  </c:pt>
                  <c:pt idx="3">
                    <c:v>2.8290163190291655</c:v>
                  </c:pt>
                </c:numCache>
              </c:numRef>
            </c:plus>
            <c:minus>
              <c:numRef>
                <c:f>'patient 1'!$R$13:$U$13</c:f>
                <c:numCache>
                  <c:formatCode>General</c:formatCode>
                  <c:ptCount val="4"/>
                  <c:pt idx="0">
                    <c:v>4.0211565500487518</c:v>
                  </c:pt>
                  <c:pt idx="1">
                    <c:v>4.4266127004742568</c:v>
                  </c:pt>
                  <c:pt idx="2">
                    <c:v>1.4000000000000028</c:v>
                  </c:pt>
                  <c:pt idx="3">
                    <c:v>2.82901631902916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Untreated</c:v>
              </c:pt>
              <c:pt idx="1">
                <c:v> Tubastatin A</c:v>
              </c:pt>
              <c:pt idx="2">
                <c:v> ACY-1215</c:v>
              </c:pt>
              <c:pt idx="3">
                <c:v> ACY-738</c:v>
              </c:pt>
            </c:strLit>
          </c:cat>
          <c:val>
            <c:numRef>
              <c:f>'patient 1'!$R$7:$U$7</c:f>
              <c:numCache>
                <c:formatCode>General</c:formatCode>
                <c:ptCount val="4"/>
                <c:pt idx="0">
                  <c:v>10.93</c:v>
                </c:pt>
                <c:pt idx="1">
                  <c:v>8</c:v>
                </c:pt>
                <c:pt idx="2">
                  <c:v>11.1</c:v>
                </c:pt>
                <c:pt idx="3">
                  <c:v>16.36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E70-4CCE-B9FB-1B8DD5EA377E}"/>
            </c:ext>
          </c:extLst>
        </c:ser>
        <c:ser>
          <c:idx val="1"/>
          <c:order val="1"/>
          <c:tx>
            <c:strRef>
              <c:f>'patient 1'!$L$8</c:f>
              <c:strCache>
                <c:ptCount val="1"/>
                <c:pt idx="0">
                  <c:v>MM+T Cell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ient 1'!$R$14:$U$14</c:f>
                <c:numCache>
                  <c:formatCode>General</c:formatCode>
                  <c:ptCount val="4"/>
                  <c:pt idx="0">
                    <c:v>2.1973013751721253</c:v>
                  </c:pt>
                  <c:pt idx="1">
                    <c:v>3.6198526673517164</c:v>
                  </c:pt>
                  <c:pt idx="2">
                    <c:v>1.7897858344878397</c:v>
                  </c:pt>
                  <c:pt idx="3">
                    <c:v>4.5621632295801655</c:v>
                  </c:pt>
                </c:numCache>
              </c:numRef>
            </c:plus>
            <c:minus>
              <c:numRef>
                <c:f>'patient 1'!$R$14:$U$14</c:f>
                <c:numCache>
                  <c:formatCode>General</c:formatCode>
                  <c:ptCount val="4"/>
                  <c:pt idx="0">
                    <c:v>2.1973013751721253</c:v>
                  </c:pt>
                  <c:pt idx="1">
                    <c:v>3.6198526673517164</c:v>
                  </c:pt>
                  <c:pt idx="2">
                    <c:v>1.7897858344878397</c:v>
                  </c:pt>
                  <c:pt idx="3">
                    <c:v>4.562163229580165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Untreated</c:v>
              </c:pt>
              <c:pt idx="1">
                <c:v> Tubastatin A</c:v>
              </c:pt>
              <c:pt idx="2">
                <c:v> ACY-1215</c:v>
              </c:pt>
              <c:pt idx="3">
                <c:v> ACY-738</c:v>
              </c:pt>
            </c:strLit>
          </c:cat>
          <c:val>
            <c:numRef>
              <c:f>'patient 1'!$R$8:$U$8</c:f>
              <c:numCache>
                <c:formatCode>General</c:formatCode>
                <c:ptCount val="4"/>
                <c:pt idx="0">
                  <c:v>10.306666666666667</c:v>
                </c:pt>
                <c:pt idx="1">
                  <c:v>40.466666666666669</c:v>
                </c:pt>
                <c:pt idx="2">
                  <c:v>26.266666666666666</c:v>
                </c:pt>
                <c:pt idx="3">
                  <c:v>47.96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E70-4CCE-B9FB-1B8DD5EA377E}"/>
            </c:ext>
          </c:extLst>
        </c:ser>
        <c:ser>
          <c:idx val="2"/>
          <c:order val="2"/>
          <c:tx>
            <c:strRef>
              <c:f>'patient 1'!$L$9</c:f>
              <c:strCache>
                <c:ptCount val="1"/>
                <c:pt idx="0">
                  <c:v>MM+HLA Ab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ient 1'!$R$15:$U$15</c:f>
                <c:numCache>
                  <c:formatCode>General</c:formatCode>
                  <c:ptCount val="4"/>
                  <c:pt idx="0">
                    <c:v>0.37220066272554297</c:v>
                  </c:pt>
                  <c:pt idx="1">
                    <c:v>1.3743847108191094</c:v>
                  </c:pt>
                  <c:pt idx="2">
                    <c:v>1.6862186493255653</c:v>
                  </c:pt>
                  <c:pt idx="3">
                    <c:v>0.27006172134038747</c:v>
                  </c:pt>
                </c:numCache>
              </c:numRef>
            </c:plus>
            <c:minus>
              <c:numRef>
                <c:f>'patient 1'!$R$15:$U$15</c:f>
                <c:numCache>
                  <c:formatCode>General</c:formatCode>
                  <c:ptCount val="4"/>
                  <c:pt idx="0">
                    <c:v>0.37220066272554297</c:v>
                  </c:pt>
                  <c:pt idx="1">
                    <c:v>1.3743847108191094</c:v>
                  </c:pt>
                  <c:pt idx="2">
                    <c:v>1.6862186493255653</c:v>
                  </c:pt>
                  <c:pt idx="3">
                    <c:v>0.2700617213403874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Untreated</c:v>
              </c:pt>
              <c:pt idx="1">
                <c:v> Tubastatin A</c:v>
              </c:pt>
              <c:pt idx="2">
                <c:v> ACY-1215</c:v>
              </c:pt>
              <c:pt idx="3">
                <c:v> ACY-738</c:v>
              </c:pt>
            </c:strLit>
          </c:cat>
          <c:val>
            <c:numRef>
              <c:f>'patient 1'!$R$9:$U$9</c:f>
              <c:numCache>
                <c:formatCode>General</c:formatCode>
                <c:ptCount val="4"/>
                <c:pt idx="0">
                  <c:v>6.9466666666666663</c:v>
                </c:pt>
                <c:pt idx="1">
                  <c:v>11.1</c:v>
                </c:pt>
                <c:pt idx="2">
                  <c:v>10.333333333333334</c:v>
                </c:pt>
                <c:pt idx="3">
                  <c:v>9.67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E70-4CCE-B9FB-1B8DD5EA377E}"/>
            </c:ext>
          </c:extLst>
        </c:ser>
        <c:ser>
          <c:idx val="3"/>
          <c:order val="3"/>
          <c:tx>
            <c:strRef>
              <c:f>'patient 1'!$L$10</c:f>
              <c:strCache>
                <c:ptCount val="1"/>
                <c:pt idx="0">
                  <c:v>MM+T Cells+HLA Ab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ient 1'!$R$16:$U$16</c:f>
                <c:numCache>
                  <c:formatCode>General</c:formatCode>
                  <c:ptCount val="4"/>
                  <c:pt idx="0">
                    <c:v>1.0692676621563617</c:v>
                  </c:pt>
                  <c:pt idx="1">
                    <c:v>1.1547005383792515</c:v>
                  </c:pt>
                  <c:pt idx="2">
                    <c:v>3.429771615331461</c:v>
                  </c:pt>
                  <c:pt idx="3">
                    <c:v>3.6295086903509803</c:v>
                  </c:pt>
                </c:numCache>
              </c:numRef>
            </c:plus>
            <c:minus>
              <c:numRef>
                <c:f>'patient 1'!$R$16:$U$16</c:f>
                <c:numCache>
                  <c:formatCode>General</c:formatCode>
                  <c:ptCount val="4"/>
                  <c:pt idx="0">
                    <c:v>1.0692676621563617</c:v>
                  </c:pt>
                  <c:pt idx="1">
                    <c:v>1.1547005383792515</c:v>
                  </c:pt>
                  <c:pt idx="2">
                    <c:v>3.429771615331461</c:v>
                  </c:pt>
                  <c:pt idx="3">
                    <c:v>3.629508690350980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Untreated</c:v>
              </c:pt>
              <c:pt idx="1">
                <c:v> Tubastatin A</c:v>
              </c:pt>
              <c:pt idx="2">
                <c:v> ACY-1215</c:v>
              </c:pt>
              <c:pt idx="3">
                <c:v> ACY-738</c:v>
              </c:pt>
            </c:strLit>
          </c:cat>
          <c:val>
            <c:numRef>
              <c:f>'patient 1'!$R$10:$U$10</c:f>
              <c:numCache>
                <c:formatCode>General</c:formatCode>
                <c:ptCount val="4"/>
                <c:pt idx="0">
                  <c:v>18.766666666666666</c:v>
                </c:pt>
                <c:pt idx="1">
                  <c:v>15.766666666666666</c:v>
                </c:pt>
                <c:pt idx="2">
                  <c:v>15.766666666666666</c:v>
                </c:pt>
                <c:pt idx="3">
                  <c:v>15.14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E70-4CCE-B9FB-1B8DD5EA377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4406447"/>
        <c:axId val="564289087"/>
      </c:barChart>
      <c:catAx>
        <c:axId val="57440644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289087"/>
        <c:crosses val="autoZero"/>
        <c:auto val="1"/>
        <c:lblAlgn val="ctr"/>
        <c:lblOffset val="100"/>
        <c:noMultiLvlLbl val="0"/>
      </c:catAx>
      <c:valAx>
        <c:axId val="56428908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Percent</a:t>
                </a:r>
                <a:r>
                  <a:rPr lang="en-US" sz="1200" b="1" baseline="0">
                    <a:latin typeface="Arial" panose="020B0604020202020204" pitchFamily="34" charset="0"/>
                    <a:cs typeface="Arial" panose="020B0604020202020204" pitchFamily="34" charset="0"/>
                  </a:rPr>
                  <a:t> Late </a:t>
                </a:r>
                <a:r>
                  <a:rPr lang="en-US" sz="1200" b="1" i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Apoptotic</a:t>
                </a:r>
              </a:p>
            </c:rich>
          </c:tx>
          <c:layout>
            <c:manualLayout>
              <c:xMode val="edge"/>
              <c:yMode val="edge"/>
              <c:x val="0"/>
              <c:y val="0.1789500721623356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7440644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atient 1'!$L$7</c:f>
              <c:strCache>
                <c:ptCount val="1"/>
                <c:pt idx="0">
                  <c:v>M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ient 1'!$W$13:$Z$13</c:f>
                <c:numCache>
                  <c:formatCode>General</c:formatCode>
                  <c:ptCount val="4"/>
                  <c:pt idx="0">
                    <c:v>5.6471231613981887</c:v>
                  </c:pt>
                  <c:pt idx="1">
                    <c:v>3.2100467286318368</c:v>
                  </c:pt>
                  <c:pt idx="2">
                    <c:v>1.1063603993877105</c:v>
                  </c:pt>
                  <c:pt idx="3">
                    <c:v>1.93443359496607</c:v>
                  </c:pt>
                </c:numCache>
              </c:numRef>
            </c:plus>
            <c:minus>
              <c:numRef>
                <c:f>'patient 1'!$W$13:$Z$13</c:f>
                <c:numCache>
                  <c:formatCode>General</c:formatCode>
                  <c:ptCount val="4"/>
                  <c:pt idx="0">
                    <c:v>5.6471231613981887</c:v>
                  </c:pt>
                  <c:pt idx="1">
                    <c:v>3.2100467286318368</c:v>
                  </c:pt>
                  <c:pt idx="2">
                    <c:v>1.1063603993877105</c:v>
                  </c:pt>
                  <c:pt idx="3">
                    <c:v>1.934433594966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Untreated</c:v>
              </c:pt>
              <c:pt idx="1">
                <c:v> Tubastatin A</c:v>
              </c:pt>
              <c:pt idx="2">
                <c:v> ACY-1215</c:v>
              </c:pt>
              <c:pt idx="3">
                <c:v> ACY-738</c:v>
              </c:pt>
            </c:strLit>
          </c:cat>
          <c:val>
            <c:numRef>
              <c:f>'patient 1'!$W$7:$Z$7</c:f>
              <c:numCache>
                <c:formatCode>General</c:formatCode>
                <c:ptCount val="4"/>
                <c:pt idx="0">
                  <c:v>16.400000000000002</c:v>
                </c:pt>
                <c:pt idx="1">
                  <c:v>9.7800000000000011</c:v>
                </c:pt>
                <c:pt idx="2">
                  <c:v>10.363333333333333</c:v>
                </c:pt>
                <c:pt idx="3">
                  <c:v>12.09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BE2-4E9F-B6E2-FC8CDFB9BA69}"/>
            </c:ext>
          </c:extLst>
        </c:ser>
        <c:ser>
          <c:idx val="1"/>
          <c:order val="1"/>
          <c:tx>
            <c:strRef>
              <c:f>'patient 1'!$L$8</c:f>
              <c:strCache>
                <c:ptCount val="1"/>
                <c:pt idx="0">
                  <c:v>MM+T Cell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ient 1'!$W$14:$Z$14</c:f>
                <c:numCache>
                  <c:formatCode>General</c:formatCode>
                  <c:ptCount val="4"/>
                  <c:pt idx="0">
                    <c:v>4.0634263046514505</c:v>
                  </c:pt>
                  <c:pt idx="1">
                    <c:v>3.9576929306520681</c:v>
                  </c:pt>
                  <c:pt idx="2">
                    <c:v>5.0994803656843271</c:v>
                  </c:pt>
                  <c:pt idx="3">
                    <c:v>2.4785748593361729</c:v>
                  </c:pt>
                </c:numCache>
              </c:numRef>
            </c:plus>
            <c:minus>
              <c:numRef>
                <c:f>'patient 1'!$W$14:$Z$14</c:f>
                <c:numCache>
                  <c:formatCode>General</c:formatCode>
                  <c:ptCount val="4"/>
                  <c:pt idx="0">
                    <c:v>4.0634263046514505</c:v>
                  </c:pt>
                  <c:pt idx="1">
                    <c:v>3.9576929306520681</c:v>
                  </c:pt>
                  <c:pt idx="2">
                    <c:v>5.0994803656843271</c:v>
                  </c:pt>
                  <c:pt idx="3">
                    <c:v>2.47857485933617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Untreated</c:v>
              </c:pt>
              <c:pt idx="1">
                <c:v> Tubastatin A</c:v>
              </c:pt>
              <c:pt idx="2">
                <c:v> ACY-1215</c:v>
              </c:pt>
              <c:pt idx="3">
                <c:v> ACY-738</c:v>
              </c:pt>
            </c:strLit>
          </c:cat>
          <c:val>
            <c:numRef>
              <c:f>'patient 1'!$W$8:$Z$8</c:f>
              <c:numCache>
                <c:formatCode>General</c:formatCode>
                <c:ptCount val="4"/>
                <c:pt idx="0">
                  <c:v>10.006666666666666</c:v>
                </c:pt>
                <c:pt idx="1">
                  <c:v>16.566666666666666</c:v>
                </c:pt>
                <c:pt idx="2">
                  <c:v>15.770000000000001</c:v>
                </c:pt>
                <c:pt idx="3">
                  <c:v>20.433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BE2-4E9F-B6E2-FC8CDFB9BA69}"/>
            </c:ext>
          </c:extLst>
        </c:ser>
        <c:ser>
          <c:idx val="2"/>
          <c:order val="2"/>
          <c:tx>
            <c:strRef>
              <c:f>'patient 1'!$L$9</c:f>
              <c:strCache>
                <c:ptCount val="1"/>
                <c:pt idx="0">
                  <c:v>MM+HLA Ab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ient 1'!$W$15:$Z$15</c:f>
                <c:numCache>
                  <c:formatCode>General</c:formatCode>
                  <c:ptCount val="4"/>
                  <c:pt idx="0">
                    <c:v>1.7545369759569054</c:v>
                  </c:pt>
                  <c:pt idx="1">
                    <c:v>1.3415041309415727</c:v>
                  </c:pt>
                  <c:pt idx="2">
                    <c:v>0.65199693250812141</c:v>
                  </c:pt>
                  <c:pt idx="3">
                    <c:v>1.4770353189187291</c:v>
                  </c:pt>
                </c:numCache>
              </c:numRef>
            </c:plus>
            <c:minus>
              <c:numRef>
                <c:f>'patient 1'!$W$15:$Z$15</c:f>
                <c:numCache>
                  <c:formatCode>General</c:formatCode>
                  <c:ptCount val="4"/>
                  <c:pt idx="0">
                    <c:v>1.7545369759569054</c:v>
                  </c:pt>
                  <c:pt idx="1">
                    <c:v>1.3415041309415727</c:v>
                  </c:pt>
                  <c:pt idx="2">
                    <c:v>0.65199693250812141</c:v>
                  </c:pt>
                  <c:pt idx="3">
                    <c:v>1.47703531891872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Untreated</c:v>
              </c:pt>
              <c:pt idx="1">
                <c:v> Tubastatin A</c:v>
              </c:pt>
              <c:pt idx="2">
                <c:v> ACY-1215</c:v>
              </c:pt>
              <c:pt idx="3">
                <c:v> ACY-738</c:v>
              </c:pt>
            </c:strLit>
          </c:cat>
          <c:val>
            <c:numRef>
              <c:f>'patient 1'!$W$9:$Z$9</c:f>
              <c:numCache>
                <c:formatCode>General</c:formatCode>
                <c:ptCount val="4"/>
                <c:pt idx="0">
                  <c:v>6.8</c:v>
                </c:pt>
                <c:pt idx="1">
                  <c:v>10.363333333333333</c:v>
                </c:pt>
                <c:pt idx="2">
                  <c:v>7.6000000000000005</c:v>
                </c:pt>
                <c:pt idx="3">
                  <c:v>8.126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BE2-4E9F-B6E2-FC8CDFB9BA69}"/>
            </c:ext>
          </c:extLst>
        </c:ser>
        <c:ser>
          <c:idx val="3"/>
          <c:order val="3"/>
          <c:tx>
            <c:strRef>
              <c:f>'patient 1'!$L$10</c:f>
              <c:strCache>
                <c:ptCount val="1"/>
                <c:pt idx="0">
                  <c:v>MM+T Cells+HLA Ab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ient 1'!$W$16:$Z$16</c:f>
                <c:numCache>
                  <c:formatCode>General</c:formatCode>
                  <c:ptCount val="4"/>
                  <c:pt idx="0">
                    <c:v>2.3860706890897814</c:v>
                  </c:pt>
                  <c:pt idx="1">
                    <c:v>0.47258156262526019</c:v>
                  </c:pt>
                  <c:pt idx="2">
                    <c:v>2.8000000000000056</c:v>
                  </c:pt>
                  <c:pt idx="3">
                    <c:v>5.7046764442283049</c:v>
                  </c:pt>
                </c:numCache>
              </c:numRef>
            </c:plus>
            <c:minus>
              <c:numRef>
                <c:f>'patient 1'!$W$16:$Z$16</c:f>
                <c:numCache>
                  <c:formatCode>General</c:formatCode>
                  <c:ptCount val="4"/>
                  <c:pt idx="0">
                    <c:v>2.3860706890897814</c:v>
                  </c:pt>
                  <c:pt idx="1">
                    <c:v>0.47258156262526019</c:v>
                  </c:pt>
                  <c:pt idx="2">
                    <c:v>2.8000000000000056</c:v>
                  </c:pt>
                  <c:pt idx="3">
                    <c:v>5.704676444228304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Untreated</c:v>
              </c:pt>
              <c:pt idx="1">
                <c:v> Tubastatin A</c:v>
              </c:pt>
              <c:pt idx="2">
                <c:v> ACY-1215</c:v>
              </c:pt>
              <c:pt idx="3">
                <c:v> ACY-738</c:v>
              </c:pt>
            </c:strLit>
          </c:cat>
          <c:val>
            <c:numRef>
              <c:f>'patient 1'!$W$10:$Z$10</c:f>
              <c:numCache>
                <c:formatCode>General</c:formatCode>
                <c:ptCount val="4"/>
                <c:pt idx="0">
                  <c:v>14.966666666666667</c:v>
                </c:pt>
                <c:pt idx="1">
                  <c:v>14.199999999999998</c:v>
                </c:pt>
                <c:pt idx="2">
                  <c:v>14.199999999999998</c:v>
                </c:pt>
                <c:pt idx="3">
                  <c:v>14.525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BE2-4E9F-B6E2-FC8CDFB9BA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4406447"/>
        <c:axId val="564289087"/>
      </c:barChart>
      <c:catAx>
        <c:axId val="57440644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289087"/>
        <c:crosses val="autoZero"/>
        <c:auto val="1"/>
        <c:lblAlgn val="ctr"/>
        <c:lblOffset val="100"/>
        <c:noMultiLvlLbl val="0"/>
      </c:catAx>
      <c:valAx>
        <c:axId val="564289087"/>
        <c:scaling>
          <c:orientation val="minMax"/>
          <c:max val="3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i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Percent Late Apoptotic</a:t>
                </a:r>
              </a:p>
            </c:rich>
          </c:tx>
          <c:layout>
            <c:manualLayout>
              <c:xMode val="edge"/>
              <c:yMode val="edge"/>
              <c:x val="3.330847873883084E-3"/>
              <c:y val="9.6772699375846774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7440644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atient 1'!$L$7</c:f>
              <c:strCache>
                <c:ptCount val="1"/>
                <c:pt idx="0">
                  <c:v>MM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ient 1'!$AB$13:$AE$13</c:f>
                <c:numCache>
                  <c:formatCode>General</c:formatCode>
                  <c:ptCount val="4"/>
                  <c:pt idx="0">
                    <c:v>4.5398237851264494</c:v>
                  </c:pt>
                  <c:pt idx="1">
                    <c:v>2.3263813101037338</c:v>
                  </c:pt>
                  <c:pt idx="2">
                    <c:v>1.7071320979935987</c:v>
                  </c:pt>
                  <c:pt idx="3">
                    <c:v>3.6487988891323306</c:v>
                  </c:pt>
                </c:numCache>
              </c:numRef>
            </c:plus>
            <c:minus>
              <c:numRef>
                <c:f>'patient 1'!$AB$13:$AE$13</c:f>
                <c:numCache>
                  <c:formatCode>General</c:formatCode>
                  <c:ptCount val="4"/>
                  <c:pt idx="0">
                    <c:v>4.5398237851264494</c:v>
                  </c:pt>
                  <c:pt idx="1">
                    <c:v>2.3263813101037338</c:v>
                  </c:pt>
                  <c:pt idx="2">
                    <c:v>1.7071320979935987</c:v>
                  </c:pt>
                  <c:pt idx="3">
                    <c:v>3.64879888913233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Untreated</c:v>
              </c:pt>
              <c:pt idx="1">
                <c:v>Tubastatin A</c:v>
              </c:pt>
              <c:pt idx="2">
                <c:v>ACY-1215</c:v>
              </c:pt>
              <c:pt idx="3">
                <c:v>ACY-738</c:v>
              </c:pt>
            </c:strLit>
          </c:cat>
          <c:val>
            <c:numRef>
              <c:f>'patient 1'!$AB$7:$AE$7</c:f>
              <c:numCache>
                <c:formatCode>General</c:formatCode>
                <c:ptCount val="4"/>
                <c:pt idx="0">
                  <c:v>14.800000000000002</c:v>
                </c:pt>
                <c:pt idx="1">
                  <c:v>11.455</c:v>
                </c:pt>
                <c:pt idx="2">
                  <c:v>13.799999999999999</c:v>
                </c:pt>
                <c:pt idx="3">
                  <c:v>8.633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6F8-4CC1-A53D-BCEC273A26A3}"/>
            </c:ext>
          </c:extLst>
        </c:ser>
        <c:ser>
          <c:idx val="1"/>
          <c:order val="1"/>
          <c:tx>
            <c:strRef>
              <c:f>'patient 1'!$L$8</c:f>
              <c:strCache>
                <c:ptCount val="1"/>
                <c:pt idx="0">
                  <c:v>MM+T Cells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ient 1'!$AB$14:$AE$14</c:f>
                <c:numCache>
                  <c:formatCode>General</c:formatCode>
                  <c:ptCount val="4"/>
                  <c:pt idx="0">
                    <c:v>3.6061105547852144</c:v>
                  </c:pt>
                  <c:pt idx="1">
                    <c:v>4.3661577311560054</c:v>
                  </c:pt>
                  <c:pt idx="2">
                    <c:v>6.7175144212722016</c:v>
                  </c:pt>
                  <c:pt idx="3">
                    <c:v>9.2197252309021422</c:v>
                  </c:pt>
                </c:numCache>
              </c:numRef>
            </c:plus>
            <c:minus>
              <c:numRef>
                <c:f>'patient 1'!$AB$14:$AE$14</c:f>
                <c:numCache>
                  <c:formatCode>General</c:formatCode>
                  <c:ptCount val="4"/>
                  <c:pt idx="0">
                    <c:v>3.6061105547852144</c:v>
                  </c:pt>
                  <c:pt idx="1">
                    <c:v>4.3661577311560054</c:v>
                  </c:pt>
                  <c:pt idx="2">
                    <c:v>6.7175144212722016</c:v>
                  </c:pt>
                  <c:pt idx="3">
                    <c:v>9.219725230902142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Untreated</c:v>
              </c:pt>
              <c:pt idx="1">
                <c:v>Tubastatin A</c:v>
              </c:pt>
              <c:pt idx="2">
                <c:v>ACY-1215</c:v>
              </c:pt>
              <c:pt idx="3">
                <c:v>ACY-738</c:v>
              </c:pt>
            </c:strLit>
          </c:cat>
          <c:val>
            <c:numRef>
              <c:f>'patient 1'!$AB$8:$AE$8</c:f>
              <c:numCache>
                <c:formatCode>General</c:formatCode>
                <c:ptCount val="4"/>
                <c:pt idx="0">
                  <c:v>12.536666666666667</c:v>
                </c:pt>
                <c:pt idx="1">
                  <c:v>36.566666666666663</c:v>
                </c:pt>
                <c:pt idx="2">
                  <c:v>25.75</c:v>
                </c:pt>
                <c:pt idx="3">
                  <c:v>32.7333333333333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6F8-4CC1-A53D-BCEC273A26A3}"/>
            </c:ext>
          </c:extLst>
        </c:ser>
        <c:ser>
          <c:idx val="2"/>
          <c:order val="2"/>
          <c:tx>
            <c:strRef>
              <c:f>'patient 1'!$L$9</c:f>
              <c:strCache>
                <c:ptCount val="1"/>
                <c:pt idx="0">
                  <c:v>MM+HLA Ab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ient 1'!$AB$15:$AE$15</c:f>
                <c:numCache>
                  <c:formatCode>General</c:formatCode>
                  <c:ptCount val="4"/>
                  <c:pt idx="0">
                    <c:v>3.9634202401461285</c:v>
                  </c:pt>
                  <c:pt idx="1">
                    <c:v>1.1048529313895128</c:v>
                  </c:pt>
                  <c:pt idx="2">
                    <c:v>2.0911798902374152</c:v>
                  </c:pt>
                  <c:pt idx="3">
                    <c:v>1.2744148984272485</c:v>
                  </c:pt>
                </c:numCache>
              </c:numRef>
            </c:plus>
            <c:minus>
              <c:numRef>
                <c:f>'patient 1'!$AB$15:$AE$15</c:f>
                <c:numCache>
                  <c:formatCode>General</c:formatCode>
                  <c:ptCount val="4"/>
                  <c:pt idx="0">
                    <c:v>3.9634202401461285</c:v>
                  </c:pt>
                  <c:pt idx="1">
                    <c:v>1.1048529313895128</c:v>
                  </c:pt>
                  <c:pt idx="2">
                    <c:v>2.0911798902374152</c:v>
                  </c:pt>
                  <c:pt idx="3">
                    <c:v>1.274414898427248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Untreated</c:v>
              </c:pt>
              <c:pt idx="1">
                <c:v>Tubastatin A</c:v>
              </c:pt>
              <c:pt idx="2">
                <c:v>ACY-1215</c:v>
              </c:pt>
              <c:pt idx="3">
                <c:v>ACY-738</c:v>
              </c:pt>
            </c:strLit>
          </c:cat>
          <c:val>
            <c:numRef>
              <c:f>'patient 1'!$AB$9:$AE$9</c:f>
              <c:numCache>
                <c:formatCode>General</c:formatCode>
                <c:ptCount val="4"/>
                <c:pt idx="0">
                  <c:v>9.93</c:v>
                </c:pt>
                <c:pt idx="1">
                  <c:v>13.799999999999999</c:v>
                </c:pt>
                <c:pt idx="2">
                  <c:v>8.586666666666666</c:v>
                </c:pt>
                <c:pt idx="3">
                  <c:v>10.3733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6F8-4CC1-A53D-BCEC273A26A3}"/>
            </c:ext>
          </c:extLst>
        </c:ser>
        <c:ser>
          <c:idx val="3"/>
          <c:order val="3"/>
          <c:tx>
            <c:strRef>
              <c:f>'patient 1'!$L$10</c:f>
              <c:strCache>
                <c:ptCount val="1"/>
                <c:pt idx="0">
                  <c:v>MM+T Cells+HLA Ab</c:v>
                </c:pt>
              </c:strCache>
            </c:strRef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atient 1'!$AB$16:$AE$16</c:f>
                <c:numCache>
                  <c:formatCode>General</c:formatCode>
                  <c:ptCount val="4"/>
                  <c:pt idx="0">
                    <c:v>1.501110699893027</c:v>
                  </c:pt>
                  <c:pt idx="1">
                    <c:v>2.1385353243126963</c:v>
                  </c:pt>
                  <c:pt idx="2">
                    <c:v>3.5360052790307499</c:v>
                  </c:pt>
                  <c:pt idx="3">
                    <c:v>1.8929694486000914</c:v>
                  </c:pt>
                </c:numCache>
              </c:numRef>
            </c:plus>
            <c:minus>
              <c:numRef>
                <c:f>'patient 1'!$AB$16:$AE$16</c:f>
                <c:numCache>
                  <c:formatCode>General</c:formatCode>
                  <c:ptCount val="4"/>
                  <c:pt idx="0">
                    <c:v>1.501110699893027</c:v>
                  </c:pt>
                  <c:pt idx="1">
                    <c:v>2.1385353243126963</c:v>
                  </c:pt>
                  <c:pt idx="2">
                    <c:v>3.5360052790307499</c:v>
                  </c:pt>
                  <c:pt idx="3">
                    <c:v>1.89296944860009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Untreated</c:v>
              </c:pt>
              <c:pt idx="1">
                <c:v>Tubastatin A</c:v>
              </c:pt>
              <c:pt idx="2">
                <c:v>ACY-1215</c:v>
              </c:pt>
              <c:pt idx="3">
                <c:v>ACY-738</c:v>
              </c:pt>
            </c:strLit>
          </c:cat>
          <c:val>
            <c:numRef>
              <c:f>'patient 1'!$AB$10:$AE$10</c:f>
              <c:numCache>
                <c:formatCode>General</c:formatCode>
                <c:ptCount val="4"/>
                <c:pt idx="0">
                  <c:v>18.433333333333334</c:v>
                </c:pt>
                <c:pt idx="1">
                  <c:v>11.100000000000001</c:v>
                </c:pt>
                <c:pt idx="2">
                  <c:v>15.966666666666667</c:v>
                </c:pt>
                <c:pt idx="3">
                  <c:v>19.96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6F8-4CC1-A53D-BCEC273A26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4406447"/>
        <c:axId val="564289087"/>
      </c:barChart>
      <c:catAx>
        <c:axId val="57440644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64289087"/>
        <c:crosses val="autoZero"/>
        <c:auto val="1"/>
        <c:lblAlgn val="ctr"/>
        <c:lblOffset val="100"/>
        <c:noMultiLvlLbl val="0"/>
      </c:catAx>
      <c:valAx>
        <c:axId val="564289087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>
                    <a:latin typeface="Arial" panose="020B0604020202020204" pitchFamily="34" charset="0"/>
                    <a:cs typeface="Arial" panose="020B0604020202020204" pitchFamily="34" charset="0"/>
                  </a:rPr>
                  <a:t>Percent</a:t>
                </a:r>
                <a:r>
                  <a:rPr lang="en-US" sz="1200" b="1" baseline="0">
                    <a:latin typeface="Arial" panose="020B0604020202020204" pitchFamily="34" charset="0"/>
                    <a:cs typeface="Arial" panose="020B0604020202020204" pitchFamily="34" charset="0"/>
                  </a:rPr>
                  <a:t> Late Apoptotic</a:t>
                </a:r>
                <a:endParaRPr lang="en-US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0"/>
              <c:y val="0.1205950741671943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7440644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7D377B7-C823-472C-9E09-6D86554DC02C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F9BC96-858B-41C2-877C-3E56BFBCC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73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87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1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29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49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3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0B188207-8C32-D4F4-0A55-15CA99E4C8F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84631548"/>
              </p:ext>
            </p:extLst>
          </p:nvPr>
        </p:nvGraphicFramePr>
        <p:xfrm>
          <a:off x="2248819" y="3003459"/>
          <a:ext cx="3812843" cy="28148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08FE3CDE-02D7-4924-93F3-4E7AF5851EC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89974634"/>
              </p:ext>
            </p:extLst>
          </p:nvPr>
        </p:nvGraphicFramePr>
        <p:xfrm>
          <a:off x="2248819" y="291869"/>
          <a:ext cx="3642246" cy="263572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AAAEACB9-A82C-4F43-B7F0-40AB559AA61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80719225"/>
              </p:ext>
            </p:extLst>
          </p:nvPr>
        </p:nvGraphicFramePr>
        <p:xfrm>
          <a:off x="6543963" y="2985993"/>
          <a:ext cx="3812843" cy="284978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562905E1-36B5-44B0-995F-C566B65D1A1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72156948"/>
              </p:ext>
            </p:extLst>
          </p:nvPr>
        </p:nvGraphicFramePr>
        <p:xfrm>
          <a:off x="6479625" y="330717"/>
          <a:ext cx="3582538" cy="26027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2025183" y="19779"/>
            <a:ext cx="9717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16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643182" y="137602"/>
            <a:ext cx="109356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>
                <a:latin typeface="Arial" panose="020B0604020202020204" pitchFamily="34" charset="0"/>
                <a:cs typeface="Arial" panose="020B0604020202020204" pitchFamily="34" charset="0"/>
              </a:rPr>
              <a:t>Patient #1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797433" y="137602"/>
            <a:ext cx="109356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>
                <a:latin typeface="Arial" panose="020B0604020202020204" pitchFamily="34" charset="0"/>
                <a:cs typeface="Arial" panose="020B0604020202020204" pitchFamily="34" charset="0"/>
              </a:rPr>
              <a:t>Patient #2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903601" y="3003459"/>
            <a:ext cx="109356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>
                <a:latin typeface="Arial" panose="020B0604020202020204" pitchFamily="34" charset="0"/>
                <a:cs typeface="Arial" panose="020B0604020202020204" pitchFamily="34" charset="0"/>
              </a:rPr>
              <a:t>Patient #4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643182" y="3003459"/>
            <a:ext cx="109356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b="1">
                <a:latin typeface="Arial" panose="020B0604020202020204" pitchFamily="34" charset="0"/>
                <a:cs typeface="Arial" panose="020B0604020202020204" pitchFamily="34" charset="0"/>
              </a:rPr>
              <a:t>Patient #3</a:t>
            </a:r>
          </a:p>
        </p:txBody>
      </p:sp>
      <p:sp>
        <p:nvSpPr>
          <p:cNvPr id="2" name="Rectangle 1"/>
          <p:cNvSpPr/>
          <p:nvPr/>
        </p:nvSpPr>
        <p:spPr>
          <a:xfrm>
            <a:off x="2248819" y="5818310"/>
            <a:ext cx="8282517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ea typeface="Times New Roman" panose="02020603050405020304" pitchFamily="18" charset="0"/>
              </a:rPr>
              <a:t>Fig. S16.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Effect of anti-HLA antibody on the generation of apoptotic MM cells after treatment with HDCA6 inhibitors and co-culture with autologous T-cells. MM patient CD138</a:t>
            </a:r>
            <a:r>
              <a:rPr lang="en-US" sz="1200" baseline="300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+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cells (20,000/ sample) were treated with each HDAC6 inhibitor (1 uM) for 24 h followed by incubated with 0.5 ug/mL mouse anti-HLA ABC antibody W6/32 (catalog number 14-9983-82, Fisher Scientific, Pittsburgh, PA) followed by co-culture with T-cells (E:T 2:1). The percent of apoptotic cells was quantitated by flow cytometry. Values represent the average of triplicate measurements. Error bars represent the SD of the mean. 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15603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5</TotalTime>
  <Words>136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James Joseph</dc:creator>
  <cp:lastModifiedBy>Driscoll, James Joseph</cp:lastModifiedBy>
  <cp:revision>101</cp:revision>
  <cp:lastPrinted>2024-03-02T18:31:01Z</cp:lastPrinted>
  <dcterms:created xsi:type="dcterms:W3CDTF">2022-08-15T18:48:13Z</dcterms:created>
  <dcterms:modified xsi:type="dcterms:W3CDTF">2024-05-03T22:13:43Z</dcterms:modified>
</cp:coreProperties>
</file>